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6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62"/>
    <p:restoredTop sz="96327"/>
  </p:normalViewPr>
  <p:slideViewPr>
    <p:cSldViewPr snapToGrid="0" snapToObjects="1">
      <p:cViewPr>
        <p:scale>
          <a:sx n="156" d="100"/>
          <a:sy n="156" d="100"/>
        </p:scale>
        <p:origin x="1024" y="9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CB084-276F-704B-949C-C25BC19025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8FEA409-EC81-4448-BC39-829A3818C5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071CA-C593-7549-A72C-2A12D91BF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C95657-C219-5548-9F60-E2700A5F1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AB565A-6913-9943-BBA4-1A0810FA2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89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0E4DD6-33C8-1B46-8405-AFD21A43C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8AC548-761F-2747-B7AF-1A89CDC3C0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882B74-1B6E-D443-A9F5-D92FA9462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3B75A0-6731-CD41-AE68-FD59397FF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37CE12-E94E-3447-A34B-B372FEB864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631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DFBC42-286C-0A4E-ADA7-85650A5B54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DF0A39-F8E7-4845-BD2D-FD30220E65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08B34-5520-D94B-A63F-B5F41587A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6DB72E-EB8A-3945-9612-83A3F38F3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5D74E3-DF9A-9446-B34E-B8532A9DA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744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4808AC-B9C6-1241-9579-E377F1DE82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0BDF85-6A24-8B44-8812-61A0027A22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6DB725-5955-2343-9AFE-68073EA7D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EB4FBD-6853-A54B-BE23-CF45549CA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4484F5-3E8C-E147-8ED2-DAD0E40DD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225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4FB89C-531D-7347-B76E-5009ACFBB8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9BD9AE-749D-2E40-9D7D-775CDD8B74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D18D84-CFA2-CE48-A962-BD2D64E2CB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7F95F4-8B29-0641-A0E8-0CB00AE46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33504B-38F8-8A4E-A7B4-E51097703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204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390742-A4D4-1642-A76A-EBEB912453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1960FD-A7F1-734E-904F-2577A7CBB7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91C1B2-CD86-584E-BB13-CB896D8B9F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792F0B-3287-6C45-AC3C-39F2E5068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0DED2A-B6CC-4648-A2EC-4A5F7A4F4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E64347-953D-7047-A51E-CC5209CC9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355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6A4088-F22A-894E-A7CB-EBFCD68416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951E89-8461-DA42-B821-990B4116C0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DDEEDC-B116-EA4D-89FE-6695682DB4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FC5FB9-D3E8-1D43-8593-5082E06F64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77C4B1-B9DA-794E-8D73-52D6EE2088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ED7899-4614-E547-83CA-7278A831D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A245AD-5DB1-A848-8AB2-9B96DAF63D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59C4DB6-67CF-1F45-B1DB-8E76B51E9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303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EDAF9-9417-2F4B-909E-39EDB48B61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772636-A070-A44F-BCA4-05860E6F0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6072C7-3F46-C04E-85F6-1DE83CC06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BBCF0F-1953-6A48-9428-1530F7B09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823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26EDFE2-26C6-C64D-96A4-BD0B96F28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972877-23F0-3445-94B2-6ECE006984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25F3B40-5C5D-E14F-A410-23325DCB3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017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387CB3-1C2A-554E-B036-1435F6E831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C5A296-4F5B-0F42-AB20-6A72077977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95FDE8-34F9-5841-BB29-49B440773B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7B93A7-DCEC-9C42-BE6D-8F7467D93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CAA6B4-622E-9A4F-A21A-88E626DB0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DB46BC-A117-F043-9B80-5120F214A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300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05A405-6EF7-7544-B656-65EFA4FF49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E014B4-DD3A-F145-8FB4-0A9D611D6C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025B64-6641-E54C-8C45-B86251B9F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8A6E78-6C3B-E04F-B887-E8DDFDD04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328A9D-BEE5-D049-B45C-75764F37B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F0E38C-3EA2-134E-A252-B18F76DBE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150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68C7C7F-712D-FC4C-9B23-8CD78B9313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DF49CE-D687-2046-8506-368DF91537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664A6E-0F86-E444-8B17-0B9CD22B43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A05D3C-ACBD-2A4D-BE56-921261B0180B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1FC5FE-C10D-B04D-8509-EDFDBEBEC2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E1A578-5C57-9B43-85D1-0830581430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7BA664-AA64-A940-808A-9C9CD3039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16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71AFE312-A3E1-1A47-AD3C-38BA259E0341}"/>
              </a:ext>
            </a:extLst>
          </p:cNvPr>
          <p:cNvSpPr txBox="1"/>
          <p:nvPr/>
        </p:nvSpPr>
        <p:spPr>
          <a:xfrm>
            <a:off x="8098971" y="0"/>
            <a:ext cx="22175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no treatment</a:t>
            </a:r>
          </a:p>
          <a:p>
            <a:r>
              <a:rPr lang="en-US" dirty="0"/>
              <a:t>5 mi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26E6E68-8173-5F49-B9F6-9B12E9B79F5B}"/>
              </a:ext>
            </a:extLst>
          </p:cNvPr>
          <p:cNvSpPr txBox="1"/>
          <p:nvPr/>
        </p:nvSpPr>
        <p:spPr>
          <a:xfrm>
            <a:off x="2180501" y="0"/>
            <a:ext cx="22175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no treatment</a:t>
            </a:r>
          </a:p>
          <a:p>
            <a:r>
              <a:rPr lang="en-US" dirty="0"/>
              <a:t>0 min</a:t>
            </a:r>
          </a:p>
        </p:txBody>
      </p:sp>
      <p:pic>
        <p:nvPicPr>
          <p:cNvPr id="27" name="Picture 26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52731DC5-A408-AF48-87A0-F6EFB274B7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2571" y="643467"/>
            <a:ext cx="4247936" cy="557541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6E19EC34-A155-FE4A-B700-8C8A501DA3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8437" y="643467"/>
            <a:ext cx="4247936" cy="5575416"/>
          </a:xfrm>
          <a:prstGeom prst="rect">
            <a:avLst/>
          </a:prstGeom>
        </p:spPr>
      </p:pic>
      <p:sp>
        <p:nvSpPr>
          <p:cNvPr id="30" name="Rectangle 29">
            <a:extLst>
              <a:ext uri="{FF2B5EF4-FFF2-40B4-BE49-F238E27FC236}">
                <a16:creationId xmlns:a16="http://schemas.microsoft.com/office/drawing/2014/main" id="{CD9EDD83-94D0-424B-B683-10EFDFE4F58B}"/>
              </a:ext>
            </a:extLst>
          </p:cNvPr>
          <p:cNvSpPr/>
          <p:nvPr/>
        </p:nvSpPr>
        <p:spPr>
          <a:xfrm>
            <a:off x="3566539" y="3694344"/>
            <a:ext cx="791936" cy="64633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4D411F40-85DE-854A-9B22-7B27FB70A1C6}"/>
              </a:ext>
            </a:extLst>
          </p:cNvPr>
          <p:cNvSpPr/>
          <p:nvPr/>
        </p:nvSpPr>
        <p:spPr>
          <a:xfrm>
            <a:off x="8552405" y="3694344"/>
            <a:ext cx="791936" cy="64633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4136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37AC8F3-3C7C-1445-8821-3ACBF0210A1D}"/>
              </a:ext>
            </a:extLst>
          </p:cNvPr>
          <p:cNvSpPr txBox="1"/>
          <p:nvPr/>
        </p:nvSpPr>
        <p:spPr>
          <a:xfrm>
            <a:off x="8098971" y="0"/>
            <a:ext cx="22175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no treatment</a:t>
            </a:r>
          </a:p>
          <a:p>
            <a:r>
              <a:rPr lang="en-US" dirty="0"/>
              <a:t>15 m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F113EC8-4925-F24C-A592-8952621566EC}"/>
              </a:ext>
            </a:extLst>
          </p:cNvPr>
          <p:cNvSpPr txBox="1"/>
          <p:nvPr/>
        </p:nvSpPr>
        <p:spPr>
          <a:xfrm>
            <a:off x="2180501" y="0"/>
            <a:ext cx="22175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no treatment</a:t>
            </a:r>
          </a:p>
          <a:p>
            <a:r>
              <a:rPr lang="en-US" dirty="0"/>
              <a:t>10 min</a:t>
            </a:r>
          </a:p>
        </p:txBody>
      </p:sp>
      <p:pic>
        <p:nvPicPr>
          <p:cNvPr id="13" name="Picture 12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DA777AB6-E984-D54C-A30B-BFEAE9F710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1809" y="643466"/>
            <a:ext cx="4247937" cy="5575417"/>
          </a:xfrm>
          <a:prstGeom prst="rect">
            <a:avLst/>
          </a:prstGeom>
        </p:spPr>
      </p:pic>
      <p:pic>
        <p:nvPicPr>
          <p:cNvPr id="15" name="Picture 14" descr="A picture containing text&#10;&#10;Description automatically generated">
            <a:extLst>
              <a:ext uri="{FF2B5EF4-FFF2-40B4-BE49-F238E27FC236}">
                <a16:creationId xmlns:a16="http://schemas.microsoft.com/office/drawing/2014/main" id="{B91080AC-941B-4A4A-83AF-92F95F6696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8438" y="643466"/>
            <a:ext cx="4247936" cy="5575416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F3EDE9C6-D9DF-114A-AEB2-9E518138E82A}"/>
              </a:ext>
            </a:extLst>
          </p:cNvPr>
          <p:cNvSpPr/>
          <p:nvPr/>
        </p:nvSpPr>
        <p:spPr>
          <a:xfrm>
            <a:off x="3186793" y="3759658"/>
            <a:ext cx="791936" cy="64633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1FBCA18-33D7-0846-8147-2808F077C088}"/>
              </a:ext>
            </a:extLst>
          </p:cNvPr>
          <p:cNvSpPr/>
          <p:nvPr/>
        </p:nvSpPr>
        <p:spPr>
          <a:xfrm>
            <a:off x="8335736" y="3759658"/>
            <a:ext cx="791936" cy="64633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987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018F1B-A7CF-334D-877D-E05D86EDE308}"/>
              </a:ext>
            </a:extLst>
          </p:cNvPr>
          <p:cNvSpPr txBox="1"/>
          <p:nvPr/>
        </p:nvSpPr>
        <p:spPr>
          <a:xfrm>
            <a:off x="8098971" y="0"/>
            <a:ext cx="22175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no treatment</a:t>
            </a:r>
          </a:p>
          <a:p>
            <a:r>
              <a:rPr lang="en-US" dirty="0"/>
              <a:t>25 m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95C6256-5849-284B-B236-2AE60861733A}"/>
              </a:ext>
            </a:extLst>
          </p:cNvPr>
          <p:cNvSpPr txBox="1"/>
          <p:nvPr/>
        </p:nvSpPr>
        <p:spPr>
          <a:xfrm>
            <a:off x="2180501" y="0"/>
            <a:ext cx="22175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no treatment</a:t>
            </a:r>
          </a:p>
          <a:p>
            <a:r>
              <a:rPr lang="en-US" dirty="0"/>
              <a:t>20 mi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23FC819-A05E-0B44-A7F9-E321D43F64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5334" y="643467"/>
            <a:ext cx="4247936" cy="5575416"/>
          </a:xfrm>
          <a:prstGeom prst="rect">
            <a:avLst/>
          </a:prstGeom>
        </p:spPr>
      </p:pic>
      <p:pic>
        <p:nvPicPr>
          <p:cNvPr id="13" name="Picture 12" descr="A screenshot of a video game&#10;&#10;Description automatically generated with medium confidence">
            <a:extLst>
              <a:ext uri="{FF2B5EF4-FFF2-40B4-BE49-F238E27FC236}">
                <a16:creationId xmlns:a16="http://schemas.microsoft.com/office/drawing/2014/main" id="{28325364-01BC-2545-81F5-649354DC41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8436" y="643466"/>
            <a:ext cx="4247935" cy="5575415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856AF6A5-37DA-964B-96F3-8C2462DE1CDB}"/>
              </a:ext>
            </a:extLst>
          </p:cNvPr>
          <p:cNvSpPr/>
          <p:nvPr/>
        </p:nvSpPr>
        <p:spPr>
          <a:xfrm>
            <a:off x="8316686" y="3743330"/>
            <a:ext cx="791936" cy="64633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7F31C68-D011-CE45-803D-0729D5BF1D47}"/>
              </a:ext>
            </a:extLst>
          </p:cNvPr>
          <p:cNvSpPr/>
          <p:nvPr/>
        </p:nvSpPr>
        <p:spPr>
          <a:xfrm>
            <a:off x="3023507" y="3743330"/>
            <a:ext cx="791936" cy="64633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2403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C0DFD0F-46C0-C440-A6AD-7D54D0BF68CE}"/>
              </a:ext>
            </a:extLst>
          </p:cNvPr>
          <p:cNvSpPr txBox="1"/>
          <p:nvPr/>
        </p:nvSpPr>
        <p:spPr>
          <a:xfrm>
            <a:off x="8098971" y="0"/>
            <a:ext cx="22175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no treatment</a:t>
            </a:r>
          </a:p>
          <a:p>
            <a:r>
              <a:rPr lang="en-US" dirty="0"/>
              <a:t>35 m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DF0FED7-149E-F64D-B198-ED6EF9099F13}"/>
              </a:ext>
            </a:extLst>
          </p:cNvPr>
          <p:cNvSpPr txBox="1"/>
          <p:nvPr/>
        </p:nvSpPr>
        <p:spPr>
          <a:xfrm>
            <a:off x="2180501" y="0"/>
            <a:ext cx="22175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no treatment</a:t>
            </a:r>
          </a:p>
          <a:p>
            <a:r>
              <a:rPr lang="en-US" dirty="0"/>
              <a:t>30 min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59C6017-EC14-3C42-AC1E-FB5672020F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9757" y="643467"/>
            <a:ext cx="4247936" cy="5575416"/>
          </a:xfrm>
          <a:prstGeom prst="rect">
            <a:avLst/>
          </a:prstGeom>
        </p:spPr>
      </p:pic>
      <p:pic>
        <p:nvPicPr>
          <p:cNvPr id="9" name="Picture 8" descr="A screenshot of a video game&#10;&#10;Description automatically generated with medium confidence">
            <a:extLst>
              <a:ext uri="{FF2B5EF4-FFF2-40B4-BE49-F238E27FC236}">
                <a16:creationId xmlns:a16="http://schemas.microsoft.com/office/drawing/2014/main" id="{6882E875-1F6E-E044-9438-82EED5C28F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56568" y="643467"/>
            <a:ext cx="4247936" cy="5575416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753FED41-33EE-C748-B5E0-1276820C5E03}"/>
              </a:ext>
            </a:extLst>
          </p:cNvPr>
          <p:cNvSpPr/>
          <p:nvPr/>
        </p:nvSpPr>
        <p:spPr>
          <a:xfrm>
            <a:off x="2881993" y="3746053"/>
            <a:ext cx="791936" cy="64633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5D0B95B-BA5E-5443-A9FB-6C4620A9E227}"/>
              </a:ext>
            </a:extLst>
          </p:cNvPr>
          <p:cNvSpPr/>
          <p:nvPr/>
        </p:nvSpPr>
        <p:spPr>
          <a:xfrm>
            <a:off x="7802336" y="3767823"/>
            <a:ext cx="791936" cy="64633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143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40</Words>
  <Application>Microsoft Macintosh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iang-Chen Chou</dc:creator>
  <cp:lastModifiedBy>Hsiang-Chen Chou</cp:lastModifiedBy>
  <cp:revision>3</cp:revision>
  <dcterms:created xsi:type="dcterms:W3CDTF">2021-01-26T16:22:06Z</dcterms:created>
  <dcterms:modified xsi:type="dcterms:W3CDTF">2021-01-26T16:43:53Z</dcterms:modified>
</cp:coreProperties>
</file>